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926E94D-EA21-426B-9F27-2B4E1C30E984}" v="2" dt="2026-03-31T00:53:49.77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88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辰巳　めぐみ" userId="S::megumi_tatsumi@ncnp.go.jp::88b1893c-db63-4bb5-9dca-a6ce3447aab8" providerId="AD" clId="Web-{6926E94D-EA21-426B-9F27-2B4E1C30E984}"/>
    <pc:docChg chg="modSld">
      <pc:chgData name="辰巳　めぐみ" userId="S::megumi_tatsumi@ncnp.go.jp::88b1893c-db63-4bb5-9dca-a6ce3447aab8" providerId="AD" clId="Web-{6926E94D-EA21-426B-9F27-2B4E1C30E984}" dt="2026-03-31T00:53:49.776" v="0" actId="20577"/>
      <pc:docMkLst>
        <pc:docMk/>
      </pc:docMkLst>
      <pc:sldChg chg="modSp">
        <pc:chgData name="辰巳　めぐみ" userId="S::megumi_tatsumi@ncnp.go.jp::88b1893c-db63-4bb5-9dca-a6ce3447aab8" providerId="AD" clId="Web-{6926E94D-EA21-426B-9F27-2B4E1C30E984}" dt="2026-03-31T00:53:49.776" v="0" actId="20577"/>
        <pc:sldMkLst>
          <pc:docMk/>
          <pc:sldMk cId="3285713202" sldId="256"/>
        </pc:sldMkLst>
        <pc:spChg chg="mod">
          <ac:chgData name="辰巳　めぐみ" userId="S::megumi_tatsumi@ncnp.go.jp::88b1893c-db63-4bb5-9dca-a6ce3447aab8" providerId="AD" clId="Web-{6926E94D-EA21-426B-9F27-2B4E1C30E984}" dt="2026-03-31T00:53:49.776" v="0" actId="20577"/>
          <ac:spMkLst>
            <pc:docMk/>
            <pc:sldMk cId="3285713202" sldId="256"/>
            <ac:spMk id="5" creationId="{131A1956-03FD-E9AD-3AD1-02E5585409FB}"/>
          </ac:spMkLst>
        </pc:spChg>
      </pc:sldChg>
    </pc:docChg>
  </pc:docChgLst>
  <pc:docChgLst>
    <pc:chgData name="辰巳　めぐみ" userId="88b1893c-db63-4bb5-9dca-a6ce3447aab8" providerId="ADAL" clId="{4C98BF49-9253-44F8-8335-0E5DA0562794}"/>
    <pc:docChg chg="undo redo custSel modSld">
      <pc:chgData name="辰巳　めぐみ" userId="88b1893c-db63-4bb5-9dca-a6ce3447aab8" providerId="ADAL" clId="{4C98BF49-9253-44F8-8335-0E5DA0562794}" dt="2026-03-25T02:46:27.250" v="159" actId="1076"/>
      <pc:docMkLst>
        <pc:docMk/>
      </pc:docMkLst>
      <pc:sldChg chg="addSp delSp modSp mod">
        <pc:chgData name="辰巳　めぐみ" userId="88b1893c-db63-4bb5-9dca-a6ce3447aab8" providerId="ADAL" clId="{4C98BF49-9253-44F8-8335-0E5DA0562794}" dt="2026-03-25T02:46:27.250" v="159" actId="1076"/>
        <pc:sldMkLst>
          <pc:docMk/>
          <pc:sldMk cId="3285713202" sldId="256"/>
        </pc:sldMkLst>
        <pc:picChg chg="add mod ord">
          <ac:chgData name="辰巳　めぐみ" userId="88b1893c-db63-4bb5-9dca-a6ce3447aab8" providerId="ADAL" clId="{4C98BF49-9253-44F8-8335-0E5DA0562794}" dt="2026-03-25T02:44:19.014" v="134" actId="167"/>
          <ac:picMkLst>
            <pc:docMk/>
            <pc:sldMk cId="3285713202" sldId="256"/>
            <ac:picMk id="2" creationId="{92CC6A16-2CE1-3269-CCC2-00F90F8DCDC1}"/>
          </ac:picMkLst>
        </pc:picChg>
        <pc:picChg chg="add mod ord">
          <ac:chgData name="辰巳　めぐみ" userId="88b1893c-db63-4bb5-9dca-a6ce3447aab8" providerId="ADAL" clId="{4C98BF49-9253-44F8-8335-0E5DA0562794}" dt="2026-03-25T02:44:15.942" v="133" actId="167"/>
          <ac:picMkLst>
            <pc:docMk/>
            <pc:sldMk cId="3285713202" sldId="256"/>
            <ac:picMk id="28" creationId="{BC6532C4-52A5-A1A8-815E-E5F6AD76C77F}"/>
          </ac:picMkLst>
        </pc:picChg>
        <pc:picChg chg="add mod ord">
          <ac:chgData name="辰巳　めぐみ" userId="88b1893c-db63-4bb5-9dca-a6ce3447aab8" providerId="ADAL" clId="{4C98BF49-9253-44F8-8335-0E5DA0562794}" dt="2026-03-25T02:44:54.685" v="140" actId="1076"/>
          <ac:picMkLst>
            <pc:docMk/>
            <pc:sldMk cId="3285713202" sldId="256"/>
            <ac:picMk id="29" creationId="{D89A42C1-A703-4477-027F-D6BE04950696}"/>
          </ac:picMkLst>
        </pc:picChg>
        <pc:picChg chg="add mod ord">
          <ac:chgData name="辰巳　めぐみ" userId="88b1893c-db63-4bb5-9dca-a6ce3447aab8" providerId="ADAL" clId="{4C98BF49-9253-44F8-8335-0E5DA0562794}" dt="2026-03-25T02:45:34.019" v="146" actId="1076"/>
          <ac:picMkLst>
            <pc:docMk/>
            <pc:sldMk cId="3285713202" sldId="256"/>
            <ac:picMk id="30" creationId="{023FE10D-FF88-21B5-E0B1-97656B4FE77F}"/>
          </ac:picMkLst>
        </pc:picChg>
        <pc:picChg chg="add mod ord">
          <ac:chgData name="辰巳　めぐみ" userId="88b1893c-db63-4bb5-9dca-a6ce3447aab8" providerId="ADAL" clId="{4C98BF49-9253-44F8-8335-0E5DA0562794}" dt="2026-03-25T02:45:59.635" v="153" actId="1076"/>
          <ac:picMkLst>
            <pc:docMk/>
            <pc:sldMk cId="3285713202" sldId="256"/>
            <ac:picMk id="31" creationId="{859E9452-FD18-8C39-FDB3-04F8471C566E}"/>
          </ac:picMkLst>
        </pc:picChg>
        <pc:picChg chg="add mod ord">
          <ac:chgData name="辰巳　めぐみ" userId="88b1893c-db63-4bb5-9dca-a6ce3447aab8" providerId="ADAL" clId="{4C98BF49-9253-44F8-8335-0E5DA0562794}" dt="2026-03-25T02:46:27.250" v="159" actId="1076"/>
          <ac:picMkLst>
            <pc:docMk/>
            <pc:sldMk cId="3285713202" sldId="256"/>
            <ac:picMk id="32" creationId="{2F774F96-8258-6660-99AD-833C32A99E7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83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222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442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824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6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63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926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250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1329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985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620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979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図 31">
            <a:extLst>
              <a:ext uri="{FF2B5EF4-FFF2-40B4-BE49-F238E27FC236}">
                <a16:creationId xmlns:a16="http://schemas.microsoft.com/office/drawing/2014/main" id="{2F774F96-8258-6660-99AD-833C32A99E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53363" y="2784871"/>
            <a:ext cx="2044629" cy="21600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859E9452-FD18-8C39-FDB3-04F8471C56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85248" y="2789496"/>
            <a:ext cx="2047834" cy="2160000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023FE10D-FF88-21B5-E0B1-97656B4FE7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9504" y="2805501"/>
            <a:ext cx="2041425" cy="216000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D89A42C1-A703-4477-027F-D6BE0495069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50158" y="220093"/>
            <a:ext cx="2047834" cy="216000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92CC6A16-2CE1-3269-CCC2-00F90F8DCD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0202" y="220093"/>
            <a:ext cx="2041424" cy="216000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BC6532C4-52A5-A1A8-815E-E5F6AD76C77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66112" y="223542"/>
            <a:ext cx="2047667" cy="2160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1A1956-03FD-E9AD-3AD1-02E5585409FB}"/>
              </a:ext>
            </a:extLst>
          </p:cNvPr>
          <p:cNvSpPr txBox="1"/>
          <p:nvPr/>
        </p:nvSpPr>
        <p:spPr>
          <a:xfrm>
            <a:off x="1144945" y="5134197"/>
            <a:ext cx="6854109" cy="52322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>
              <a:spcAft>
                <a:spcPts val="1000"/>
              </a:spcAft>
            </a:pPr>
            <a:r>
              <a:rPr lang="en-US" altLang="ja-JP" sz="1400" b="1">
                <a:effectLst/>
                <a:latin typeface="Times"/>
                <a:ea typeface="游明朝"/>
                <a:cs typeface="Times New Roman"/>
              </a:rPr>
              <a:t>Figure </a:t>
            </a:r>
            <a:r>
              <a:rPr lang="en-US" altLang="ja-JP" sz="1400" b="1">
                <a:latin typeface="Times"/>
                <a:ea typeface="游明朝"/>
                <a:cs typeface="Times New Roman"/>
              </a:rPr>
              <a:t>S7</a:t>
            </a:r>
            <a:r>
              <a:rPr lang="en-US" altLang="ja-JP" sz="1400" b="1">
                <a:effectLst/>
                <a:latin typeface="Times"/>
                <a:ea typeface="游明朝"/>
                <a:cs typeface="Times New Roman"/>
              </a:rPr>
              <a:t>.</a:t>
            </a:r>
            <a:r>
              <a:rPr lang="en-US" altLang="ja-JP" sz="1400">
                <a:effectLst/>
                <a:latin typeface="Times"/>
                <a:ea typeface="游明朝"/>
                <a:cs typeface="Times New Roman"/>
              </a:rPr>
              <a:t> </a:t>
            </a:r>
            <a:r>
              <a:rPr lang="en-US" altLang="ja-JP" sz="1400" b="1" dirty="0">
                <a:effectLst/>
                <a:latin typeface="Times"/>
                <a:ea typeface="游明朝"/>
                <a:cs typeface="Times New Roman"/>
              </a:rPr>
              <a:t>Impact of time and temperature before processing on the CSF proteome analyzed by volcano plots.</a:t>
            </a:r>
            <a:endParaRPr lang="ja-JP" altLang="ja-JP" sz="1400" dirty="0">
              <a:effectLst/>
              <a:latin typeface="Times"/>
              <a:ea typeface="游明朝"/>
              <a:cs typeface="Times New Roman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8BED0AB-9C38-9FAC-6A01-077E5C9B072B}"/>
              </a:ext>
            </a:extLst>
          </p:cNvPr>
          <p:cNvSpPr txBox="1"/>
          <p:nvPr/>
        </p:nvSpPr>
        <p:spPr>
          <a:xfrm>
            <a:off x="859537" y="1732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9701DB0-75AF-8D25-0859-3DAB1C9F34ED}"/>
              </a:ext>
            </a:extLst>
          </p:cNvPr>
          <p:cNvSpPr txBox="1"/>
          <p:nvPr/>
        </p:nvSpPr>
        <p:spPr>
          <a:xfrm>
            <a:off x="3126783" y="1455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64819D9-E49A-6B09-E8CD-09784DEEDD97}"/>
              </a:ext>
            </a:extLst>
          </p:cNvPr>
          <p:cNvSpPr txBox="1"/>
          <p:nvPr/>
        </p:nvSpPr>
        <p:spPr>
          <a:xfrm>
            <a:off x="5550158" y="1455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01FDB2C-2232-2138-C3DD-01115D0972A2}"/>
              </a:ext>
            </a:extLst>
          </p:cNvPr>
          <p:cNvSpPr txBox="1"/>
          <p:nvPr/>
        </p:nvSpPr>
        <p:spPr>
          <a:xfrm>
            <a:off x="859537" y="261772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95B9037-B5B6-BEA6-818E-E6480157E161}"/>
              </a:ext>
            </a:extLst>
          </p:cNvPr>
          <p:cNvSpPr txBox="1"/>
          <p:nvPr/>
        </p:nvSpPr>
        <p:spPr>
          <a:xfrm>
            <a:off x="3126783" y="261496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5920194-93D6-BA6B-FA76-EF29C43EA14F}"/>
              </a:ext>
            </a:extLst>
          </p:cNvPr>
          <p:cNvSpPr txBox="1"/>
          <p:nvPr/>
        </p:nvSpPr>
        <p:spPr>
          <a:xfrm>
            <a:off x="5550158" y="261496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633B1D7-665C-95C8-3AB6-6587913DDE76}"/>
              </a:ext>
            </a:extLst>
          </p:cNvPr>
          <p:cNvSpPr txBox="1"/>
          <p:nvPr/>
        </p:nvSpPr>
        <p:spPr>
          <a:xfrm>
            <a:off x="1399106" y="2348156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2280B79-1E2D-09E5-6564-8660F4F895D4}"/>
              </a:ext>
            </a:extLst>
          </p:cNvPr>
          <p:cNvSpPr txBox="1"/>
          <p:nvPr/>
        </p:nvSpPr>
        <p:spPr>
          <a:xfrm>
            <a:off x="3699393" y="2343185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B735E5F-1D41-4CE7-1F05-1E07C3118361}"/>
              </a:ext>
            </a:extLst>
          </p:cNvPr>
          <p:cNvSpPr txBox="1"/>
          <p:nvPr/>
        </p:nvSpPr>
        <p:spPr>
          <a:xfrm>
            <a:off x="6113500" y="2338560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DF5DDD1-7833-1E63-AB80-4EEE18C03B33}"/>
              </a:ext>
            </a:extLst>
          </p:cNvPr>
          <p:cNvSpPr txBox="1"/>
          <p:nvPr/>
        </p:nvSpPr>
        <p:spPr>
          <a:xfrm rot="16200000">
            <a:off x="254709" y="1125949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8D86381-C276-3E9B-31FA-52475C682226}"/>
              </a:ext>
            </a:extLst>
          </p:cNvPr>
          <p:cNvSpPr txBox="1"/>
          <p:nvPr/>
        </p:nvSpPr>
        <p:spPr>
          <a:xfrm rot="16200000">
            <a:off x="2550033" y="1123186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5052997-80EB-D4F7-26CA-29283457FE6C}"/>
              </a:ext>
            </a:extLst>
          </p:cNvPr>
          <p:cNvSpPr txBox="1"/>
          <p:nvPr/>
        </p:nvSpPr>
        <p:spPr>
          <a:xfrm rot="16200000">
            <a:off x="4995034" y="1123186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3D3D3F8-351E-0373-AC7A-08C8488BE70D}"/>
              </a:ext>
            </a:extLst>
          </p:cNvPr>
          <p:cNvSpPr txBox="1"/>
          <p:nvPr/>
        </p:nvSpPr>
        <p:spPr>
          <a:xfrm>
            <a:off x="1399106" y="4901628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50EFDE2-6935-150D-E43B-1691C2040A39}"/>
              </a:ext>
            </a:extLst>
          </p:cNvPr>
          <p:cNvSpPr txBox="1"/>
          <p:nvPr/>
        </p:nvSpPr>
        <p:spPr>
          <a:xfrm>
            <a:off x="3699393" y="4896657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9CDC5E2-E583-3C64-7873-AD3A27D871A7}"/>
              </a:ext>
            </a:extLst>
          </p:cNvPr>
          <p:cNvSpPr txBox="1"/>
          <p:nvPr/>
        </p:nvSpPr>
        <p:spPr>
          <a:xfrm>
            <a:off x="6113500" y="4892032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93B17BE-BB10-C96F-8CEC-1220B2278361}"/>
              </a:ext>
            </a:extLst>
          </p:cNvPr>
          <p:cNvSpPr txBox="1"/>
          <p:nvPr/>
        </p:nvSpPr>
        <p:spPr>
          <a:xfrm rot="16200000">
            <a:off x="254709" y="3679421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F01DD71-0D50-1372-02A2-AE4E334E99C9}"/>
              </a:ext>
            </a:extLst>
          </p:cNvPr>
          <p:cNvSpPr txBox="1"/>
          <p:nvPr/>
        </p:nvSpPr>
        <p:spPr>
          <a:xfrm rot="16200000">
            <a:off x="2550033" y="3676658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1BC74CA-D70D-9BF9-1C78-1FB58AFFD2F7}"/>
              </a:ext>
            </a:extLst>
          </p:cNvPr>
          <p:cNvSpPr txBox="1"/>
          <p:nvPr/>
        </p:nvSpPr>
        <p:spPr>
          <a:xfrm rot="16200000">
            <a:off x="4995034" y="3676658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571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9e658bc-5f5e-48b2-a593-8f2a4dff4e86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4E485A41FBE0840AEF03DC6126CF7E9" ma:contentTypeVersion="10" ma:contentTypeDescription="新しいドキュメントを作成します。" ma:contentTypeScope="" ma:versionID="b7fc72b48302197a3c00e12c5a71d0f2">
  <xsd:schema xmlns:xsd="http://www.w3.org/2001/XMLSchema" xmlns:xs="http://www.w3.org/2001/XMLSchema" xmlns:p="http://schemas.microsoft.com/office/2006/metadata/properties" xmlns:ns2="09e658bc-5f5e-48b2-a593-8f2a4dff4e86" targetNamespace="http://schemas.microsoft.com/office/2006/metadata/properties" ma:root="true" ma:fieldsID="3811df9a92dabbc9fbde200746e96434" ns2:_="">
    <xsd:import namespace="09e658bc-5f5e-48b2-a593-8f2a4dff4e8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e658bc-5f5e-48b2-a593-8f2a4dff4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559d5a2e-65d4-4456-94da-aa20a3af47a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FAB396D-A4EF-436C-8A0C-D30680AEAFC9}">
  <ds:schemaRefs>
    <ds:schemaRef ds:uri="http://www.w3.org/XML/1998/namespace"/>
    <ds:schemaRef ds:uri="http://purl.org/dc/elements/1.1/"/>
    <ds:schemaRef ds:uri="http://schemas.microsoft.com/office/2006/metadata/properties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09e658bc-5f5e-48b2-a593-8f2a4dff4e86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55A5B391-10D7-479C-A1B9-D15F704BE6F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BA5BEAB-ADAF-4ED9-AC41-5F15145DF10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9e658bc-5f5e-48b2-a593-8f2a4dff4e8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1</TotalTime>
  <Words>61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辰巳　めぐみ</dc:creator>
  <cp:lastModifiedBy>辰巳　めぐみ</cp:lastModifiedBy>
  <cp:revision>9</cp:revision>
  <dcterms:created xsi:type="dcterms:W3CDTF">2025-03-28T03:13:18Z</dcterms:created>
  <dcterms:modified xsi:type="dcterms:W3CDTF">2026-03-31T07:59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4E485A41FBE0840AEF03DC6126CF7E9</vt:lpwstr>
  </property>
  <property fmtid="{D5CDD505-2E9C-101B-9397-08002B2CF9AE}" pid="3" name="MediaServiceImageTags">
    <vt:lpwstr/>
  </property>
</Properties>
</file>